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73" d="100"/>
          <a:sy n="73" d="100"/>
        </p:scale>
        <p:origin x="3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39296-115B-42DE-B682-1DEB25B5DC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A6D3AD-B230-4BCF-83B8-DE2A767715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E27A51-BB3C-4DBC-832E-5A4955C79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AF56E4-0ED1-4D22-9541-C1AD846E3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BB9BE1-F76D-4816-BAA1-4748D2047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280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132AAF-5387-48AC-AD90-E8C4610B2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84EDA3-1219-42A4-AD47-031EBF3F25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637B12-B18A-45C5-B122-0846D94EB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3D7E49-4F59-406B-8BDA-6C2A00293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1DCD2C-0EE9-4454-8068-D7DEB01FC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664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4C5FA8-555A-4AB3-8619-07D3C50A9E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8EBFBE-3488-4CC6-817C-824F05290C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E12E17-3568-4F9F-99EA-DFFD64062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6D297-2CBA-4FD6-A436-2F401957B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9D00A1-E66B-4E8D-A86B-7A47ED2F5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621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DA3C3-56F9-4654-8479-D63F973282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90D462-1E5F-4C93-B5CF-2466203F8F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9852AC-9D97-4669-8CEF-1D72FDDDD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ED812-351C-4C04-B576-9DA9D0B36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3FB21-93B6-45A4-A253-5BE4C4DCA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025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6E868-4793-4AF8-8651-6A1D8CBAE1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54A058-ECDC-4171-B746-B51DA2F77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387039-727A-419C-9F2E-7F57C7014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A16680-425D-4B1A-854A-BAD4ED502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F986FE-DB45-4E00-972C-DBA4DEA99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83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06D37-6E4B-4A30-84AB-4EA6E8DCE6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E5AD1F-5A50-4D6B-A3AA-19126EC9E3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FDE8F0-12AE-4CFF-AFA5-9F0C52A59B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2414C3-AB9E-4D01-9F4C-52BFF1CDC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CA9C73-BD80-42E3-81C7-CE3179E2F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A23781-C0FD-46D9-819A-B9E4BD633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955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5FB59D-3EA2-43D2-809F-7939CAA32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A2C201-E73E-4158-9288-C807EDFA0A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F4F558-1BAF-4CE3-9BD2-6C8930854D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77249E-FE5C-44FA-B992-8C0548CFCA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C07E51-0DEA-4C2A-A73D-4347573089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36503A-31B6-419D-B066-849CBDEE4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FBA92D-1333-4520-9AFD-F75AAFA1D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C96CFD-400D-4A9C-ABEB-DB9B580D5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119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5B9492-56C0-4766-8559-D37DEBCEE4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DD6829-BF79-4F7C-8BE8-02FCAD51E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FBBEE6-A831-4FAC-9CA6-8C0DEA654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7C20D8-5B0E-4D88-88FB-E147DA417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313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8564D2-756B-45EA-9A93-CE40FA8B1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D9579F-7348-4F06-B3FB-51F9E3710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0F090B-A07B-4CF2-B40E-EA8C48300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945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894376-DCC3-4490-9210-2294D42A4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24ABE-9136-4146-949A-5B98C31D4C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B1A42C-08D4-4DEC-9A69-F39C218EF1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D24943-61EF-4D68-AB4E-EC839AB41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8445E5-5511-45B1-9CE8-267DCAE63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8DEF3F-01F2-4266-A364-49FA3F83B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947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C30129-3C5B-4D18-91AE-903431A0EA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92FBC0-F2BA-445C-B337-CD479ED3F8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3B5EF0-1481-4C7E-B54C-B985362866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D86695-54DB-47E0-A814-0163F5FE9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9CE979-8D8C-4097-8B9C-F4487B3C0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9DDB07-1581-462D-BF5E-7A53B367D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086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DC5393-C20E-4E59-911A-6108A78DE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9A9C85-4DB7-46B2-B77F-408FEA35BD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D25F06-E86D-481A-9633-E2DFC9303F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A0466-CEA5-4FD0-B24B-EDDC32BF724F}" type="datetimeFigureOut">
              <a:rPr lang="en-US" smtClean="0"/>
              <a:t>1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14907-BD79-42B5-8B19-268F216766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BC4D2F-9A16-4DD9-93BA-9CA22AA1CF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1233A-732B-4EBB-909C-3C105D2C9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65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478D0A-E2FA-4A94-A804-CE56F4AA9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</a:t>
            </a:fld>
            <a:endParaRPr lang="en-US"/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D4B52BD5-B294-4EFE-8FF7-51AA32062D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-557873" y="2474306"/>
            <a:ext cx="6770369" cy="1997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C2123F7-CDE9-47B6-AF9F-C626033631BE}"/>
              </a:ext>
            </a:extLst>
          </p:cNvPr>
          <p:cNvGraphicFramePr>
            <a:graphicFrameLocks noGrp="1"/>
          </p:cNvGraphicFramePr>
          <p:nvPr/>
        </p:nvGraphicFramePr>
        <p:xfrm>
          <a:off x="7406120" y="1447800"/>
          <a:ext cx="2715801" cy="4464336"/>
        </p:xfrm>
        <a:graphic>
          <a:graphicData uri="http://schemas.openxmlformats.org/drawingml/2006/table">
            <a:tbl>
              <a:tblPr/>
              <a:tblGrid>
                <a:gridCol w="429801">
                  <a:extLst>
                    <a:ext uri="{9D8B030D-6E8A-4147-A177-3AD203B41FA5}">
                      <a16:colId xmlns:a16="http://schemas.microsoft.com/office/drawing/2014/main" val="4185614703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3360707279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1331961364"/>
                    </a:ext>
                  </a:extLst>
                </a:gridCol>
              </a:tblGrid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Fibroblast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5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3154388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odocyte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70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0564860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Macrophage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896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5597717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4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Monocyte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47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9907784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Natural killer cells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56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9300796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6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Endothelial Cell, Arteriolar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46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3298155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7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Endothelial Cell, peritubular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98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0051908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Glomerular Capillary Endothelial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900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0141633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9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Vascular Smooth Muscle Cell and Mesangia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65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3706353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10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89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0831595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212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651917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2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987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8831548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81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7436166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4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89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112369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412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4426583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16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oximal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52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8865473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7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Intercalated Beta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74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4946584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Intercalated Alpha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977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781528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9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Transitioning Principal Cell / Intercalated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6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052669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0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Thick Ascending Limb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34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5920957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Distal Convoluted Tubule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90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6142684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2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Connecting Tubule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45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9292204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B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4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5438230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4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Cytotoxic T-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09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9402423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T Cell, activated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095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8051226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6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T cell, memory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89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8341590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7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rincipal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164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2855661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Cortical Connecting Tubule Principal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414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2727818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29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Ascending Thin Limb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656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333663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30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Parietal Epithelial Cell / Loop of Henle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158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2197994"/>
                  </a:ext>
                </a:extLst>
              </a:tr>
              <a:tr h="142585"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31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>
                          <a:effectLst/>
                        </a:rPr>
                        <a:t>Descending Thin Limb Cell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9F9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effectLst/>
                        </a:rPr>
                        <a:t>743</a:t>
                      </a:r>
                    </a:p>
                  </a:txBody>
                  <a:tcPr marL="44098" marR="44098" marT="18374" marB="18374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0958101"/>
                  </a:ext>
                </a:extLst>
              </a:tr>
            </a:tbl>
          </a:graphicData>
        </a:graphic>
      </p:graphicFrame>
      <p:pic>
        <p:nvPicPr>
          <p:cNvPr id="8" name="Picture 2">
            <a:extLst>
              <a:ext uri="{FF2B5EF4-FFF2-40B4-BE49-F238E27FC236}">
                <a16:creationId xmlns:a16="http://schemas.microsoft.com/office/drawing/2014/main" id="{2CEBA17B-EFCD-41B6-8AE9-49FA05C72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181529" y="2410517"/>
            <a:ext cx="6868887" cy="20260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9F89D5E-B51D-4266-8D16-7640866A396A}"/>
              </a:ext>
            </a:extLst>
          </p:cNvPr>
          <p:cNvSpPr txBox="1"/>
          <p:nvPr/>
        </p:nvSpPr>
        <p:spPr>
          <a:xfrm>
            <a:off x="7239001" y="304801"/>
            <a:ext cx="31242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. Figure1. WFDC2 and FEX19 expression patten in renal cells </a:t>
            </a:r>
          </a:p>
        </p:txBody>
      </p:sp>
    </p:spTree>
    <p:extLst>
      <p:ext uri="{BB962C8B-B14F-4D97-AF65-F5344CB8AC3E}">
        <p14:creationId xmlns:p14="http://schemas.microsoft.com/office/powerpoint/2010/main" val="2024274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Office PowerPoint</Application>
  <PresentationFormat>Widescreen</PresentationFormat>
  <Paragraphs>9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, Chengguo</dc:creator>
  <cp:lastModifiedBy>Wei, Chengguo</cp:lastModifiedBy>
  <cp:revision>1</cp:revision>
  <dcterms:created xsi:type="dcterms:W3CDTF">2021-01-31T16:58:49Z</dcterms:created>
  <dcterms:modified xsi:type="dcterms:W3CDTF">2021-01-31T16:59:15Z</dcterms:modified>
</cp:coreProperties>
</file>